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8" r:id="rId2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00"/>
    <a:srgbClr val="000000"/>
    <a:srgbClr val="FBE5D6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95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086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041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772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19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668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0787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4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6176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705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564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2992654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4A05F-7D26-4DF5-AAF3-375857C92025}" type="datetimeFigureOut">
              <a:rPr lang="en-GB" smtClean="0"/>
              <a:t>0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592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518716" y="10844664"/>
            <a:ext cx="988406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9.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axanthin production in </a:t>
            </a:r>
            <a:r>
              <a:rPr lang="en-GB" sz="20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coli</a:t>
            </a:r>
            <a:r>
              <a:rPr lang="en-GB" sz="2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2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optimised culture conditions</a:t>
            </a:r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li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simultaneously transformed with the vector of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est (</a:t>
            </a:r>
            <a:r>
              <a:rPr lang="en-GB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GB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 fusion)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pACCAR16ΔcrtX (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rotene producer). </a:t>
            </a:r>
            <a:r>
              <a:rPr lang="en-GB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Bacterial </a:t>
            </a:r>
            <a:r>
              <a:rPr lang="en-GB" sz="20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recultures</a:t>
            </a:r>
            <a:r>
              <a:rPr lang="en-GB" sz="2000" dirty="0">
                <a:latin typeface="Times New Roman" panose="02020603050405020304" pitchFamily="18" charset="0"/>
                <a:ea typeface="Calibri" panose="020F0502020204030204" pitchFamily="34" charset="0"/>
              </a:rPr>
              <a:t> were grown at 37 °C and subsequently incubated at 28 °C for 1.5 h, 3 h, 6 h, 9 h, 22 h and 26 h. </a:t>
            </a:r>
            <a:r>
              <a:rPr lang="en-GB" sz="2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staxanthin levels in </a:t>
            </a:r>
            <a:r>
              <a:rPr lang="en-GB" sz="2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µg/</a:t>
            </a:r>
            <a:r>
              <a:rPr lang="en-GB" sz="2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DCW</a:t>
            </a:r>
            <a:r>
              <a:rPr lang="en-GB" sz="2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2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in mg/L are represented in blue and red for </a:t>
            </a:r>
            <a:r>
              <a:rPr lang="en-GB" sz="2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Z+W</a:t>
            </a:r>
            <a:r>
              <a:rPr lang="en-GB" sz="2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2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Z</a:t>
            </a:r>
            <a:r>
              <a:rPr lang="en-GB" sz="2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W, respectively. The recorded OD600 of the bacteria is shown in green. </a:t>
            </a:r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304" y="6200702"/>
            <a:ext cx="10828886" cy="38412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2899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0</TotalTime>
  <Words>105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